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7" r:id="rId2"/>
    <p:sldId id="289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992" y="-6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CDFC3-062B-4C86-B19F-62EB14732681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BB66-C3AA-48A4-84D7-716CF95CB8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8084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CDFC3-062B-4C86-B19F-62EB14732681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BB66-C3AA-48A4-84D7-716CF95CB8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1506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CDFC3-062B-4C86-B19F-62EB14732681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BB66-C3AA-48A4-84D7-716CF95CB8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6875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CDFC3-062B-4C86-B19F-62EB14732681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BB66-C3AA-48A4-84D7-716CF95CB8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030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CDFC3-062B-4C86-B19F-62EB14732681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BB66-C3AA-48A4-84D7-716CF95CB8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244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CDFC3-062B-4C86-B19F-62EB14732681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BB66-C3AA-48A4-84D7-716CF95CB8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58447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CDFC3-062B-4C86-B19F-62EB14732681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BB66-C3AA-48A4-84D7-716CF95CB8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947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CDFC3-062B-4C86-B19F-62EB14732681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BB66-C3AA-48A4-84D7-716CF95CB8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7971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CDFC3-062B-4C86-B19F-62EB14732681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BB66-C3AA-48A4-84D7-716CF95CB8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1132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CDFC3-062B-4C86-B19F-62EB14732681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BB66-C3AA-48A4-84D7-716CF95CB8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817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CDFC3-062B-4C86-B19F-62EB14732681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5BB66-C3AA-48A4-84D7-716CF95CB8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467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5CDFC3-062B-4C86-B19F-62EB14732681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65BB66-C3AA-48A4-84D7-716CF95CB8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0066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160520" y="1447800"/>
            <a:ext cx="6459480" cy="4419600"/>
            <a:chOff x="1371601" y="533401"/>
            <a:chExt cx="6459480" cy="4419600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84276" y="995066"/>
              <a:ext cx="2046805" cy="15576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17075" y="1006282"/>
              <a:ext cx="2061919" cy="15464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>
              <a:off x="1436124" y="544463"/>
              <a:ext cx="218681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. PH1 patient without </a:t>
              </a:r>
            </a:p>
            <a:p>
              <a:pPr algn="ctr"/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phrocalcinosis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or stones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" name="Picture 5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61271" y="1004591"/>
              <a:ext cx="2046805" cy="1548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" name="TextBox 9"/>
            <p:cNvSpPr txBox="1"/>
            <p:nvPr/>
          </p:nvSpPr>
          <p:spPr>
            <a:xfrm>
              <a:off x="3876928" y="544460"/>
              <a:ext cx="166744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B. PH1 patient with </a:t>
              </a:r>
            </a:p>
            <a:p>
              <a:pPr algn="ctr"/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phrocalcinosis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973955" y="533401"/>
              <a:ext cx="166744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. PH1 patient with 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dney stones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371601" y="2514601"/>
              <a:ext cx="29979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Customized protein array template </a:t>
              </a:r>
            </a:p>
          </p:txBody>
        </p:sp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29843" y="2772550"/>
              <a:ext cx="6301237" cy="21804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14" name="TextBox 13"/>
          <p:cNvSpPr txBox="1"/>
          <p:nvPr/>
        </p:nvSpPr>
        <p:spPr>
          <a:xfrm>
            <a:off x="257175" y="457200"/>
            <a:ext cx="8458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gure 1: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Exampl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ustomized antibodies or proteins arrays from 24h cell-free urine collected from type 1 primar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yperoxaluri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PH1) patients withou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ephrocalcinosi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NC) or kidney stones (A) and with NC (B) or Stones (C). The proteins or antibodies array template (D) is customized based on the proteins involved soft tissue calcification. </a:t>
            </a:r>
          </a:p>
        </p:txBody>
      </p:sp>
    </p:spTree>
    <p:extLst>
      <p:ext uri="{BB962C8B-B14F-4D97-AF65-F5344CB8AC3E}">
        <p14:creationId xmlns:p14="http://schemas.microsoft.com/office/powerpoint/2010/main" val="19307318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81000" y="152400"/>
            <a:ext cx="8458200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bbreviations:  C5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Complement component 5a; CD14, cluster of differentiation 14; CD40, cluster of differentiation 40; CFIII, coagulation factor III; CFVII, coagulation factor VII; CFXIV, coagulation factor XIV(protein C); CRP, C-reactive protein; E-cadherin, epithelial cadherin; EGFR, epidermal growth factor receptor; E-selectin, endothelial selectin; GP VI, glycoprotein VI; ICAM-1, Intercellular adhesion molecule 1; IL-10, interleukin 10; Insulin R, insulin receptor; LDLR, low density lipoprotein receptor; MCP-1, monocyte chemoattractant protein-1; MMP-2, matrix metalloproteinase-2; MMP-9, matrix metalloproteinase-9; OPN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osteopont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; OPG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osteoprotegr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; PAI-1, plasminogen activator inhibitor-1; PDGFRβ, platelet-derived growth factor receptor beta; PDGF-AA, platelet-derived growth factor-AA; PDGF-BB, platelet-derived growth factor-BB; PECAM-1, platelet endothelial cell adhesion molecule-1; pref-1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readibocyt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actor-1; RANTES, regulated upon activation, normal T-cell expressed and secreted; TFPI, tissue factor pathway inhibitor; TIMP1, tissue inhibitor of matrix metalloproteinase 1; TIMP2, tissue inhibitor of matrix metalloproteinase 2; TLR4, toll like receptor 4; VCAM-1: Vascular cell adhesion protein-1; VE-cadherin, vascular endothelial cadherin; VEGFR1, vascular endothelial growth factor receptor 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2479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31</TotalTime>
  <Words>320</Words>
  <Application>Microsoft Office PowerPoint</Application>
  <PresentationFormat>On-screen Show (4:3)</PresentationFormat>
  <Paragraphs>9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thuvel  Jayachandran</dc:creator>
  <cp:lastModifiedBy>Muthuvel  Jayachandran</cp:lastModifiedBy>
  <cp:revision>130</cp:revision>
  <dcterms:created xsi:type="dcterms:W3CDTF">2018-10-10T16:32:27Z</dcterms:created>
  <dcterms:modified xsi:type="dcterms:W3CDTF">2020-09-02T17:32:41Z</dcterms:modified>
</cp:coreProperties>
</file>